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</p:sldIdLst>
  <p:sldSz cx="6858000" cy="9906000" type="A4"/>
  <p:notesSz cx="7104063" cy="10234613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4" d="100"/>
          <a:sy n="74" d="100"/>
        </p:scale>
        <p:origin x="3114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 smtClean="0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8CFFE-96A2-4FFB-8207-BFD493579D6D}" type="datetimeFigureOut">
              <a:rPr lang="it-IT" smtClean="0"/>
              <a:t>18/10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F1458-56EA-46BA-BB92-66577F90C3D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340845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8CFFE-96A2-4FFB-8207-BFD493579D6D}" type="datetimeFigureOut">
              <a:rPr lang="it-IT" smtClean="0"/>
              <a:t>18/10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F1458-56EA-46BA-BB92-66577F90C3D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189470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8CFFE-96A2-4FFB-8207-BFD493579D6D}" type="datetimeFigureOut">
              <a:rPr lang="it-IT" smtClean="0"/>
              <a:t>18/10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F1458-56EA-46BA-BB92-66577F90C3D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546394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8CFFE-96A2-4FFB-8207-BFD493579D6D}" type="datetimeFigureOut">
              <a:rPr lang="it-IT" smtClean="0"/>
              <a:t>18/10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F1458-56EA-46BA-BB92-66577F90C3D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519118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8CFFE-96A2-4FFB-8207-BFD493579D6D}" type="datetimeFigureOut">
              <a:rPr lang="it-IT" smtClean="0"/>
              <a:t>18/10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F1458-56EA-46BA-BB92-66577F90C3D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019001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8CFFE-96A2-4FFB-8207-BFD493579D6D}" type="datetimeFigureOut">
              <a:rPr lang="it-IT" smtClean="0"/>
              <a:t>18/10/20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F1458-56EA-46BA-BB92-66577F90C3D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421568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8CFFE-96A2-4FFB-8207-BFD493579D6D}" type="datetimeFigureOut">
              <a:rPr lang="it-IT" smtClean="0"/>
              <a:t>18/10/2019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F1458-56EA-46BA-BB92-66577F90C3D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298668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8CFFE-96A2-4FFB-8207-BFD493579D6D}" type="datetimeFigureOut">
              <a:rPr lang="it-IT" smtClean="0"/>
              <a:t>18/10/2019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F1458-56EA-46BA-BB92-66577F90C3D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98473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8CFFE-96A2-4FFB-8207-BFD493579D6D}" type="datetimeFigureOut">
              <a:rPr lang="it-IT" smtClean="0"/>
              <a:t>18/10/2019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F1458-56EA-46BA-BB92-66577F90C3D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758537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8CFFE-96A2-4FFB-8207-BFD493579D6D}" type="datetimeFigureOut">
              <a:rPr lang="it-IT" smtClean="0"/>
              <a:t>18/10/20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F1458-56EA-46BA-BB92-66577F90C3D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425460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 smtClean="0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08CFFE-96A2-4FFB-8207-BFD493579D6D}" type="datetimeFigureOut">
              <a:rPr lang="it-IT" smtClean="0"/>
              <a:t>18/10/2019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5F1458-56EA-46BA-BB92-66577F90C3D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781899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08CFFE-96A2-4FFB-8207-BFD493579D6D}" type="datetimeFigureOut">
              <a:rPr lang="it-IT" smtClean="0"/>
              <a:t>18/10/2019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5F1458-56EA-46BA-BB92-66577F90C3D3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457167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emf"/><Relationship Id="rId4" Type="http://schemas.openxmlformats.org/officeDocument/2006/relationships/image" Target="../media/image5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po 2"/>
          <p:cNvGrpSpPr/>
          <p:nvPr/>
        </p:nvGrpSpPr>
        <p:grpSpPr>
          <a:xfrm>
            <a:off x="1812688" y="1351113"/>
            <a:ext cx="2880000" cy="2634420"/>
            <a:chOff x="1812688" y="1351113"/>
            <a:chExt cx="2880000" cy="2634420"/>
          </a:xfrm>
        </p:grpSpPr>
        <p:pic>
          <p:nvPicPr>
            <p:cNvPr id="2" name="Immagine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347334" y="1351113"/>
              <a:ext cx="2160000" cy="1157512"/>
            </a:xfrm>
            <a:prstGeom prst="rect">
              <a:avLst/>
            </a:prstGeom>
          </p:spPr>
        </p:pic>
        <p:pic>
          <p:nvPicPr>
            <p:cNvPr id="50" name="Immagine 49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812688" y="2850873"/>
              <a:ext cx="2880000" cy="1134660"/>
            </a:xfrm>
            <a:prstGeom prst="rect">
              <a:avLst/>
            </a:prstGeom>
          </p:spPr>
        </p:pic>
      </p:grpSp>
      <p:sp>
        <p:nvSpPr>
          <p:cNvPr id="51" name="Rettangolo 50"/>
          <p:cNvSpPr/>
          <p:nvPr/>
        </p:nvSpPr>
        <p:spPr>
          <a:xfrm>
            <a:off x="-1666" y="4538446"/>
            <a:ext cx="6858000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sz="12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. S1. LAMP2A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 HSC70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quantification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Western blot analysis of LAMP2A and HSC70 in protein lysates from untreated (-) and TMZ-treated (+) U251 and 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98 total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ell lines. Protein signals were normalized to actin levels. Histograms show mean values of protein arbitrary units evaluated in independent experiments. Errors bars indicate standard deviation. * p&lt;0.05 treated versus untreated.</a:t>
            </a:r>
            <a:endParaRPr lang="it-IT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6" name="CasellaDiTesto 5"/>
          <p:cNvSpPr txBox="1"/>
          <p:nvPr/>
        </p:nvSpPr>
        <p:spPr>
          <a:xfrm>
            <a:off x="3000396" y="153094"/>
            <a:ext cx="8563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b="1" dirty="0" smtClean="0"/>
              <a:t>Fig. </a:t>
            </a:r>
            <a:r>
              <a:rPr lang="it-IT" b="1" smtClean="0"/>
              <a:t>S1.</a:t>
            </a:r>
            <a:endParaRPr lang="it-IT" b="1" dirty="0"/>
          </a:p>
        </p:txBody>
      </p:sp>
    </p:spTree>
    <p:extLst>
      <p:ext uri="{BB962C8B-B14F-4D97-AF65-F5344CB8AC3E}">
        <p14:creationId xmlns:p14="http://schemas.microsoft.com/office/powerpoint/2010/main" val="22510925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Rettangolo 15"/>
          <p:cNvSpPr/>
          <p:nvPr/>
        </p:nvSpPr>
        <p:spPr>
          <a:xfrm>
            <a:off x="-397" y="4538651"/>
            <a:ext cx="6858000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sz="12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. S2. </a:t>
            </a:r>
            <a:r>
              <a:rPr lang="en-US" sz="1200" b="1" i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IF-1</a:t>
            </a:r>
            <a:r>
              <a:rPr lang="en-US" sz="12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α</a:t>
            </a:r>
            <a:r>
              <a:rPr lang="en-US" sz="12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 </a:t>
            </a:r>
            <a:r>
              <a:rPr lang="en-US" sz="1200" b="1" i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EGF</a:t>
            </a:r>
            <a:r>
              <a:rPr lang="en-US" sz="12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xpression after CMA-related gene silencing.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ene expression analysis for </a:t>
            </a:r>
            <a:r>
              <a:rPr lang="en-US" sz="1200" i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IF-1α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 </a:t>
            </a:r>
            <a:r>
              <a:rPr lang="en-US" sz="1200" i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EGF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xpression in U251 and T98 cells after </a:t>
            </a:r>
            <a:r>
              <a:rPr lang="en-US" sz="1200" i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SC70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r </a:t>
            </a:r>
            <a:r>
              <a:rPr lang="en-US" sz="1200" i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HLPP1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ilencing. </a:t>
            </a:r>
            <a:r>
              <a:rPr lang="en-GB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ata of gene expression were normalized </a:t>
            </a:r>
            <a:r>
              <a:rPr lang="en-GB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or </a:t>
            </a:r>
            <a:r>
              <a:rPr lang="en-GB" sz="1200" i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β-ACTIN</a:t>
            </a:r>
            <a:r>
              <a:rPr lang="en-GB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n-GB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 the </a:t>
            </a:r>
            <a:r>
              <a:rPr lang="en-GB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ΔΔCt</a:t>
            </a:r>
            <a:r>
              <a:rPr lang="en-GB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values were expressed as FOI of the ratio between treated and control cells.</a:t>
            </a:r>
            <a:endParaRPr lang="it-IT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7" name="CasellaDiTesto 16"/>
          <p:cNvSpPr txBox="1"/>
          <p:nvPr/>
        </p:nvSpPr>
        <p:spPr>
          <a:xfrm>
            <a:off x="3000396" y="153094"/>
            <a:ext cx="8563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b="1" dirty="0" smtClean="0"/>
              <a:t>Fig. S2.</a:t>
            </a:r>
            <a:endParaRPr lang="it-IT" b="1" dirty="0"/>
          </a:p>
        </p:txBody>
      </p:sp>
      <p:grpSp>
        <p:nvGrpSpPr>
          <p:cNvPr id="3" name="Gruppo 2"/>
          <p:cNvGrpSpPr/>
          <p:nvPr/>
        </p:nvGrpSpPr>
        <p:grpSpPr>
          <a:xfrm>
            <a:off x="386425" y="949736"/>
            <a:ext cx="6358818" cy="3031312"/>
            <a:chOff x="386425" y="949736"/>
            <a:chExt cx="6358818" cy="3031312"/>
          </a:xfrm>
        </p:grpSpPr>
        <p:grpSp>
          <p:nvGrpSpPr>
            <p:cNvPr id="2" name="Gruppo 1"/>
            <p:cNvGrpSpPr/>
            <p:nvPr/>
          </p:nvGrpSpPr>
          <p:grpSpPr>
            <a:xfrm>
              <a:off x="386425" y="949736"/>
              <a:ext cx="6358818" cy="3031312"/>
              <a:chOff x="386425" y="949736"/>
              <a:chExt cx="6358818" cy="3031312"/>
            </a:xfrm>
          </p:grpSpPr>
          <p:grpSp>
            <p:nvGrpSpPr>
              <p:cNvPr id="11" name="Gruppo 10"/>
              <p:cNvGrpSpPr/>
              <p:nvPr/>
            </p:nvGrpSpPr>
            <p:grpSpPr>
              <a:xfrm>
                <a:off x="386425" y="1362766"/>
                <a:ext cx="2880000" cy="2618282"/>
                <a:chOff x="540973" y="1362766"/>
                <a:chExt cx="2880000" cy="2618282"/>
              </a:xfrm>
            </p:grpSpPr>
            <p:pic>
              <p:nvPicPr>
                <p:cNvPr id="7" name="Immagine 6"/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540973" y="1362767"/>
                  <a:ext cx="2880000" cy="2618281"/>
                </a:xfrm>
                <a:prstGeom prst="rect">
                  <a:avLst/>
                </a:prstGeom>
                <a:solidFill>
                  <a:schemeClr val="bg1"/>
                </a:solidFill>
              </p:spPr>
            </p:pic>
            <p:sp>
              <p:nvSpPr>
                <p:cNvPr id="5" name="Rettangolo 4"/>
                <p:cNvSpPr/>
                <p:nvPr/>
              </p:nvSpPr>
              <p:spPr>
                <a:xfrm>
                  <a:off x="2653048" y="1362766"/>
                  <a:ext cx="767925" cy="375881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</p:grpSp>
          <p:grpSp>
            <p:nvGrpSpPr>
              <p:cNvPr id="12" name="Gruppo 11"/>
              <p:cNvGrpSpPr/>
              <p:nvPr/>
            </p:nvGrpSpPr>
            <p:grpSpPr>
              <a:xfrm>
                <a:off x="3368289" y="1447335"/>
                <a:ext cx="3376954" cy="2520000"/>
                <a:chOff x="3265257" y="1447335"/>
                <a:chExt cx="3376954" cy="2520000"/>
              </a:xfrm>
            </p:grpSpPr>
            <p:pic>
              <p:nvPicPr>
                <p:cNvPr id="6" name="Immagine 5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3265257" y="1447335"/>
                  <a:ext cx="3376953" cy="2520000"/>
                </a:xfrm>
                <a:prstGeom prst="rect">
                  <a:avLst/>
                </a:prstGeom>
                <a:solidFill>
                  <a:schemeClr val="bg1"/>
                </a:solidFill>
              </p:spPr>
            </p:pic>
            <p:sp>
              <p:nvSpPr>
                <p:cNvPr id="10" name="Rettangolo 9"/>
                <p:cNvSpPr/>
                <p:nvPr/>
              </p:nvSpPr>
              <p:spPr>
                <a:xfrm>
                  <a:off x="6045631" y="1472258"/>
                  <a:ext cx="596580" cy="375881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</p:grpSp>
          <p:sp>
            <p:nvSpPr>
              <p:cNvPr id="13" name="Rettangolo 12"/>
              <p:cNvSpPr/>
              <p:nvPr/>
            </p:nvSpPr>
            <p:spPr>
              <a:xfrm>
                <a:off x="3037010" y="949736"/>
                <a:ext cx="783280" cy="432369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pic>
            <p:nvPicPr>
              <p:cNvPr id="14" name="Immagine 13"/>
              <p:cNvPicPr>
                <a:picLocks noChangeAspect="1"/>
              </p:cNvPicPr>
              <p:nvPr/>
            </p:nvPicPr>
            <p:blipFill rotWithShape="1">
              <a:blip r:embed="rId4"/>
              <a:srcRect l="86283" t="21710" r="2326" b="68720"/>
              <a:stretch/>
            </p:blipFill>
            <p:spPr>
              <a:xfrm>
                <a:off x="3057426" y="2637798"/>
                <a:ext cx="306782" cy="252000"/>
              </a:xfrm>
              <a:prstGeom prst="rect">
                <a:avLst/>
              </a:prstGeom>
              <a:solidFill>
                <a:schemeClr val="bg1"/>
              </a:solidFill>
            </p:spPr>
          </p:pic>
          <p:pic>
            <p:nvPicPr>
              <p:cNvPr id="15" name="Immagine 14"/>
              <p:cNvPicPr>
                <a:picLocks noChangeAspect="1"/>
              </p:cNvPicPr>
              <p:nvPr/>
            </p:nvPicPr>
            <p:blipFill rotWithShape="1">
              <a:blip r:embed="rId4"/>
              <a:srcRect l="86283" t="21710" r="2326" b="68720"/>
              <a:stretch/>
            </p:blipFill>
            <p:spPr>
              <a:xfrm>
                <a:off x="6107572" y="2635650"/>
                <a:ext cx="306782" cy="252000"/>
              </a:xfrm>
              <a:prstGeom prst="rect">
                <a:avLst/>
              </a:prstGeom>
              <a:solidFill>
                <a:schemeClr val="bg1"/>
              </a:solidFill>
            </p:spPr>
          </p:pic>
        </p:grpSp>
        <p:pic>
          <p:nvPicPr>
            <p:cNvPr id="18" name="Immagine 17"/>
            <p:cNvPicPr>
              <a:picLocks noChangeAspect="1"/>
            </p:cNvPicPr>
            <p:nvPr/>
          </p:nvPicPr>
          <p:blipFill rotWithShape="1">
            <a:blip r:embed="rId5"/>
            <a:srcRect l="72268" t="2498" r="2435" b="73648"/>
            <a:stretch/>
          </p:blipFill>
          <p:spPr>
            <a:xfrm>
              <a:off x="3081284" y="978191"/>
              <a:ext cx="720000" cy="461249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3439484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/>
          <p:cNvSpPr txBox="1"/>
          <p:nvPr/>
        </p:nvSpPr>
        <p:spPr>
          <a:xfrm>
            <a:off x="3000396" y="153094"/>
            <a:ext cx="8563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it-IT" b="1" dirty="0" smtClean="0"/>
              <a:t>Fig. S3.</a:t>
            </a:r>
            <a:endParaRPr lang="it-IT" b="1" dirty="0"/>
          </a:p>
        </p:txBody>
      </p:sp>
      <p:sp>
        <p:nvSpPr>
          <p:cNvPr id="9" name="Rettangolo 8"/>
          <p:cNvSpPr/>
          <p:nvPr/>
        </p:nvSpPr>
        <p:spPr>
          <a:xfrm>
            <a:off x="-442" y="4539065"/>
            <a:ext cx="68580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sz="12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. S3. </a:t>
            </a:r>
            <a:r>
              <a:rPr lang="en-US" sz="1200" b="1" i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OD</a:t>
            </a:r>
            <a:r>
              <a:rPr lang="en-US" sz="12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 </a:t>
            </a:r>
            <a:r>
              <a:rPr lang="en-US" sz="1200" b="1" i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ATALASE</a:t>
            </a:r>
            <a:r>
              <a:rPr lang="en-US" sz="12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asal level.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ene expression analysis of basal level for </a:t>
            </a:r>
            <a:r>
              <a:rPr lang="en-US" sz="1200" i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OD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 </a:t>
            </a:r>
            <a:r>
              <a:rPr lang="en-US" sz="1200" i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ATALASE</a:t>
            </a:r>
            <a:r>
              <a:rPr lang="en-US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xpression in U251 and T98 cells. </a:t>
            </a:r>
            <a:r>
              <a:rPr lang="en-GB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ata of gene expression were normalized </a:t>
            </a:r>
            <a:r>
              <a:rPr lang="en-GB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or </a:t>
            </a:r>
            <a:r>
              <a:rPr lang="en-GB" sz="1200" i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β-ACTIN</a:t>
            </a:r>
            <a:r>
              <a:rPr lang="en-GB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n-GB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d presented as the </a:t>
            </a:r>
            <a:r>
              <a:rPr lang="en-GB" sz="12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2^dct </a:t>
            </a:r>
            <a:r>
              <a:rPr lang="en-GB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values. </a:t>
            </a:r>
            <a:endParaRPr lang="it-IT" sz="12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uppo 2"/>
          <p:cNvGrpSpPr/>
          <p:nvPr/>
        </p:nvGrpSpPr>
        <p:grpSpPr>
          <a:xfrm>
            <a:off x="2021896" y="1085655"/>
            <a:ext cx="3036684" cy="2449207"/>
            <a:chOff x="2021896" y="1085655"/>
            <a:chExt cx="3036684" cy="2449207"/>
          </a:xfrm>
        </p:grpSpPr>
        <p:pic>
          <p:nvPicPr>
            <p:cNvPr id="4" name="Immagine 3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021896" y="1085655"/>
              <a:ext cx="2823611" cy="2449207"/>
            </a:xfrm>
            <a:prstGeom prst="rect">
              <a:avLst/>
            </a:prstGeom>
          </p:spPr>
        </p:pic>
        <p:sp>
          <p:nvSpPr>
            <p:cNvPr id="5" name="Rettangolo 4"/>
            <p:cNvSpPr/>
            <p:nvPr/>
          </p:nvSpPr>
          <p:spPr>
            <a:xfrm>
              <a:off x="2665926" y="2150772"/>
              <a:ext cx="2318198" cy="1981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8" name="Rettangolo 7"/>
            <p:cNvSpPr/>
            <p:nvPr/>
          </p:nvSpPr>
          <p:spPr>
            <a:xfrm>
              <a:off x="4296745" y="1448325"/>
              <a:ext cx="455559" cy="37403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6" name="CasellaDiTesto 5"/>
            <p:cNvSpPr txBox="1"/>
            <p:nvPr/>
          </p:nvSpPr>
          <p:spPr>
            <a:xfrm>
              <a:off x="4136595" y="1479417"/>
              <a:ext cx="61587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1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OD-2</a:t>
              </a:r>
              <a:endParaRPr lang="it-IT" sz="11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CasellaDiTesto 13"/>
            <p:cNvSpPr txBox="1"/>
            <p:nvPr/>
          </p:nvSpPr>
          <p:spPr>
            <a:xfrm>
              <a:off x="4133327" y="1634817"/>
              <a:ext cx="92525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1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ATALASE</a:t>
              </a:r>
              <a:endParaRPr lang="it-IT" sz="1100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45229211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9</TotalTime>
  <Words>180</Words>
  <Application>Microsoft Office PowerPoint</Application>
  <PresentationFormat>A4 (21x29,7 cm)</PresentationFormat>
  <Paragraphs>8</Paragraphs>
  <Slides>3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Tema di Office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Imaging</dc:creator>
  <cp:lastModifiedBy>Imaging</cp:lastModifiedBy>
  <cp:revision>15</cp:revision>
  <cp:lastPrinted>2019-09-27T12:47:19Z</cp:lastPrinted>
  <dcterms:created xsi:type="dcterms:W3CDTF">2019-07-31T13:49:40Z</dcterms:created>
  <dcterms:modified xsi:type="dcterms:W3CDTF">2019-10-18T13:47:01Z</dcterms:modified>
</cp:coreProperties>
</file>